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08" r:id="rId1"/>
  </p:sldMasterIdLst>
  <p:notesMasterIdLst>
    <p:notesMasterId r:id="rId3"/>
  </p:notesMasterIdLst>
  <p:handoutMasterIdLst>
    <p:handoutMasterId r:id="rId4"/>
  </p:handoutMasterIdLst>
  <p:sldIdLst>
    <p:sldId id="297" r:id="rId2"/>
  </p:sldIdLst>
  <p:sldSz cx="4572000" cy="3382963"/>
  <p:notesSz cx="9601200" cy="7315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936" userDrawn="1">
          <p15:clr>
            <a:srgbClr val="A4A3A4"/>
          </p15:clr>
        </p15:guide>
        <p15:guide id="2" pos="721" userDrawn="1">
          <p15:clr>
            <a:srgbClr val="A4A3A4"/>
          </p15:clr>
        </p15:guide>
        <p15:guide id="4" orient="horz" pos="134" userDrawn="1">
          <p15:clr>
            <a:srgbClr val="A4A3A4"/>
          </p15:clr>
        </p15:guide>
        <p15:guide id="6" pos="1440" userDrawn="1">
          <p15:clr>
            <a:srgbClr val="A4A3A4"/>
          </p15:clr>
        </p15:guide>
        <p15:guide id="7" pos="216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  <a:srgbClr val="006600"/>
    <a:srgbClr val="FF40FF"/>
    <a:srgbClr val="00FDFF"/>
    <a:srgbClr val="00FF00"/>
    <a:srgbClr val="EC7E89"/>
    <a:srgbClr val="E97C84"/>
    <a:srgbClr val="F38288"/>
    <a:srgbClr val="CD5585"/>
    <a:srgbClr val="B84C7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686" autoAdjust="0"/>
    <p:restoredTop sz="97522" autoAdjust="0"/>
  </p:normalViewPr>
  <p:slideViewPr>
    <p:cSldViewPr snapToGrid="0" snapToObjects="1" showGuides="1">
      <p:cViewPr varScale="1">
        <p:scale>
          <a:sx n="225" d="100"/>
          <a:sy n="225" d="100"/>
        </p:scale>
        <p:origin x="4164" y="168"/>
      </p:cViewPr>
      <p:guideLst>
        <p:guide orient="horz" pos="936"/>
        <p:guide pos="721"/>
        <p:guide orient="horz" pos="134"/>
        <p:guide pos="1440"/>
        <p:guide pos="2161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1E4E17BB-95E6-1741-AE93-F169A843E570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2"/>
            <a:ext cx="4160520" cy="367030"/>
          </a:xfrm>
          <a:prstGeom prst="rect">
            <a:avLst/>
          </a:prstGeom>
        </p:spPr>
        <p:txBody>
          <a:bodyPr vert="horz" lIns="96653" tIns="48327" rIns="96653" bIns="48327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DDB4571-8095-BF4E-9420-401CC071600D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5438458" y="2"/>
            <a:ext cx="4160520" cy="367030"/>
          </a:xfrm>
          <a:prstGeom prst="rect">
            <a:avLst/>
          </a:prstGeom>
        </p:spPr>
        <p:txBody>
          <a:bodyPr vert="horz" lIns="96653" tIns="48327" rIns="96653" bIns="48327" rtlCol="0"/>
          <a:lstStyle>
            <a:lvl1pPr algn="r">
              <a:defRPr sz="1200"/>
            </a:lvl1pPr>
          </a:lstStyle>
          <a:p>
            <a:fld id="{B9A9A5A9-2048-DC45-862E-C0322B77F3FA}" type="datetimeFigureOut">
              <a:rPr lang="en-US" smtClean="0"/>
              <a:t>9/10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0F423D1-2210-E745-A72E-F258121EE27D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6948171"/>
            <a:ext cx="4160520" cy="367029"/>
          </a:xfrm>
          <a:prstGeom prst="rect">
            <a:avLst/>
          </a:prstGeom>
        </p:spPr>
        <p:txBody>
          <a:bodyPr vert="horz" lIns="96653" tIns="48327" rIns="96653" bIns="48327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8297E99-20AD-2641-BB69-27E20118A8BE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5438458" y="6948171"/>
            <a:ext cx="4160520" cy="367029"/>
          </a:xfrm>
          <a:prstGeom prst="rect">
            <a:avLst/>
          </a:prstGeom>
        </p:spPr>
        <p:txBody>
          <a:bodyPr vert="horz" lIns="96653" tIns="48327" rIns="96653" bIns="48327" rtlCol="0" anchor="b"/>
          <a:lstStyle>
            <a:lvl1pPr algn="r">
              <a:defRPr sz="1200"/>
            </a:lvl1pPr>
          </a:lstStyle>
          <a:p>
            <a:fld id="{A1D5AC36-D550-FF41-ABB7-F6C6F1475B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938279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4160520" cy="367030"/>
          </a:xfrm>
          <a:prstGeom prst="rect">
            <a:avLst/>
          </a:prstGeom>
        </p:spPr>
        <p:txBody>
          <a:bodyPr vert="horz" lIns="96653" tIns="48327" rIns="96653" bIns="48327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438458" y="2"/>
            <a:ext cx="4160520" cy="367030"/>
          </a:xfrm>
          <a:prstGeom prst="rect">
            <a:avLst/>
          </a:prstGeom>
        </p:spPr>
        <p:txBody>
          <a:bodyPr vert="horz" lIns="96653" tIns="48327" rIns="96653" bIns="48327" rtlCol="0"/>
          <a:lstStyle>
            <a:lvl1pPr algn="r">
              <a:defRPr sz="1200"/>
            </a:lvl1pPr>
          </a:lstStyle>
          <a:p>
            <a:fld id="{3BD17408-84A5-CE4A-95E0-91CC3E57BB33}" type="datetimeFigureOut">
              <a:rPr lang="en-US" smtClean="0"/>
              <a:t>9/10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132138" y="914400"/>
            <a:ext cx="3336925" cy="24685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53" tIns="48327" rIns="96653" bIns="48327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60120" y="3520439"/>
            <a:ext cx="7680960" cy="2880361"/>
          </a:xfrm>
          <a:prstGeom prst="rect">
            <a:avLst/>
          </a:prstGeom>
        </p:spPr>
        <p:txBody>
          <a:bodyPr vert="horz" lIns="96653" tIns="48327" rIns="96653" bIns="48327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948171"/>
            <a:ext cx="4160520" cy="367029"/>
          </a:xfrm>
          <a:prstGeom prst="rect">
            <a:avLst/>
          </a:prstGeom>
        </p:spPr>
        <p:txBody>
          <a:bodyPr vert="horz" lIns="96653" tIns="48327" rIns="96653" bIns="48327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438458" y="6948171"/>
            <a:ext cx="4160520" cy="367029"/>
          </a:xfrm>
          <a:prstGeom prst="rect">
            <a:avLst/>
          </a:prstGeom>
        </p:spPr>
        <p:txBody>
          <a:bodyPr vert="horz" lIns="96653" tIns="48327" rIns="96653" bIns="48327" rtlCol="0" anchor="b"/>
          <a:lstStyle>
            <a:lvl1pPr algn="r">
              <a:defRPr sz="1200"/>
            </a:lvl1pPr>
          </a:lstStyle>
          <a:p>
            <a:fld id="{3138FF0E-91FE-BC42-9C7B-31BD5F4578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29112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2663" rtl="0" eaLnBrk="1" latinLnBrk="0" hangingPunct="1">
      <a:defRPr sz="594" kern="1200">
        <a:solidFill>
          <a:schemeClr val="tx1"/>
        </a:solidFill>
        <a:latin typeface="+mn-lt"/>
        <a:ea typeface="+mn-ea"/>
        <a:cs typeface="+mn-cs"/>
      </a:defRPr>
    </a:lvl1pPr>
    <a:lvl2pPr marL="226331" algn="l" defTabSz="452663" rtl="0" eaLnBrk="1" latinLnBrk="0" hangingPunct="1">
      <a:defRPr sz="594" kern="1200">
        <a:solidFill>
          <a:schemeClr val="tx1"/>
        </a:solidFill>
        <a:latin typeface="+mn-lt"/>
        <a:ea typeface="+mn-ea"/>
        <a:cs typeface="+mn-cs"/>
      </a:defRPr>
    </a:lvl2pPr>
    <a:lvl3pPr marL="452663" algn="l" defTabSz="452663" rtl="0" eaLnBrk="1" latinLnBrk="0" hangingPunct="1">
      <a:defRPr sz="594" kern="1200">
        <a:solidFill>
          <a:schemeClr val="tx1"/>
        </a:solidFill>
        <a:latin typeface="+mn-lt"/>
        <a:ea typeface="+mn-ea"/>
        <a:cs typeface="+mn-cs"/>
      </a:defRPr>
    </a:lvl3pPr>
    <a:lvl4pPr marL="678995" algn="l" defTabSz="452663" rtl="0" eaLnBrk="1" latinLnBrk="0" hangingPunct="1">
      <a:defRPr sz="594" kern="1200">
        <a:solidFill>
          <a:schemeClr val="tx1"/>
        </a:solidFill>
        <a:latin typeface="+mn-lt"/>
        <a:ea typeface="+mn-ea"/>
        <a:cs typeface="+mn-cs"/>
      </a:defRPr>
    </a:lvl4pPr>
    <a:lvl5pPr marL="905326" algn="l" defTabSz="452663" rtl="0" eaLnBrk="1" latinLnBrk="0" hangingPunct="1">
      <a:defRPr sz="594" kern="1200">
        <a:solidFill>
          <a:schemeClr val="tx1"/>
        </a:solidFill>
        <a:latin typeface="+mn-lt"/>
        <a:ea typeface="+mn-ea"/>
        <a:cs typeface="+mn-cs"/>
      </a:defRPr>
    </a:lvl5pPr>
    <a:lvl6pPr marL="1131659" algn="l" defTabSz="452663" rtl="0" eaLnBrk="1" latinLnBrk="0" hangingPunct="1">
      <a:defRPr sz="594" kern="1200">
        <a:solidFill>
          <a:schemeClr val="tx1"/>
        </a:solidFill>
        <a:latin typeface="+mn-lt"/>
        <a:ea typeface="+mn-ea"/>
        <a:cs typeface="+mn-cs"/>
      </a:defRPr>
    </a:lvl6pPr>
    <a:lvl7pPr marL="1357990" algn="l" defTabSz="452663" rtl="0" eaLnBrk="1" latinLnBrk="0" hangingPunct="1">
      <a:defRPr sz="594" kern="1200">
        <a:solidFill>
          <a:schemeClr val="tx1"/>
        </a:solidFill>
        <a:latin typeface="+mn-lt"/>
        <a:ea typeface="+mn-ea"/>
        <a:cs typeface="+mn-cs"/>
      </a:defRPr>
    </a:lvl7pPr>
    <a:lvl8pPr marL="1584321" algn="l" defTabSz="452663" rtl="0" eaLnBrk="1" latinLnBrk="0" hangingPunct="1">
      <a:defRPr sz="594" kern="1200">
        <a:solidFill>
          <a:schemeClr val="tx1"/>
        </a:solidFill>
        <a:latin typeface="+mn-lt"/>
        <a:ea typeface="+mn-ea"/>
        <a:cs typeface="+mn-cs"/>
      </a:defRPr>
    </a:lvl8pPr>
    <a:lvl9pPr marL="1810653" algn="l" defTabSz="452663" rtl="0" eaLnBrk="1" latinLnBrk="0" hangingPunct="1">
      <a:defRPr sz="594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42900" y="553647"/>
            <a:ext cx="3886200" cy="1177772"/>
          </a:xfrm>
        </p:spPr>
        <p:txBody>
          <a:bodyPr anchor="b"/>
          <a:lstStyle>
            <a:lvl1pPr algn="ctr">
              <a:defRPr sz="29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71500" y="1776839"/>
            <a:ext cx="3429000" cy="816766"/>
          </a:xfrm>
        </p:spPr>
        <p:txBody>
          <a:bodyPr/>
          <a:lstStyle>
            <a:lvl1pPr marL="0" indent="0" algn="ctr">
              <a:buNone/>
              <a:defRPr sz="1184"/>
            </a:lvl1pPr>
            <a:lvl2pPr marL="225537" indent="0" algn="ctr">
              <a:buNone/>
              <a:defRPr sz="987"/>
            </a:lvl2pPr>
            <a:lvl3pPr marL="451074" indent="0" algn="ctr">
              <a:buNone/>
              <a:defRPr sz="888"/>
            </a:lvl3pPr>
            <a:lvl4pPr marL="676610" indent="0" algn="ctr">
              <a:buNone/>
              <a:defRPr sz="789"/>
            </a:lvl4pPr>
            <a:lvl5pPr marL="902147" indent="0" algn="ctr">
              <a:buNone/>
              <a:defRPr sz="789"/>
            </a:lvl5pPr>
            <a:lvl6pPr marL="1127684" indent="0" algn="ctr">
              <a:buNone/>
              <a:defRPr sz="789"/>
            </a:lvl6pPr>
            <a:lvl7pPr marL="1353221" indent="0" algn="ctr">
              <a:buNone/>
              <a:defRPr sz="789"/>
            </a:lvl7pPr>
            <a:lvl8pPr marL="1578757" indent="0" algn="ctr">
              <a:buNone/>
              <a:defRPr sz="789"/>
            </a:lvl8pPr>
            <a:lvl9pPr marL="1804294" indent="0" algn="ctr">
              <a:buNone/>
              <a:defRPr sz="789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A0D40-68A1-F040-9BD5-36D632BB7D3C}" type="datetimeFigureOut">
              <a:rPr lang="en-US" smtClean="0"/>
              <a:t>9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A6C77-EFDD-C042-999E-4715030A8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75892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A0D40-68A1-F040-9BD5-36D632BB7D3C}" type="datetimeFigureOut">
              <a:rPr lang="en-US" smtClean="0"/>
              <a:t>9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A6C77-EFDD-C042-999E-4715030A8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08660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271838" y="180111"/>
            <a:ext cx="985838" cy="286690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14325" y="180111"/>
            <a:ext cx="2900363" cy="2866905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A0D40-68A1-F040-9BD5-36D632BB7D3C}" type="datetimeFigureOut">
              <a:rPr lang="en-US" smtClean="0"/>
              <a:t>9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A6C77-EFDD-C042-999E-4715030A8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18592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A0D40-68A1-F040-9BD5-36D632BB7D3C}" type="datetimeFigureOut">
              <a:rPr lang="en-US" smtClean="0"/>
              <a:t>9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A6C77-EFDD-C042-999E-4715030A8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18933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1944" y="843393"/>
            <a:ext cx="3943350" cy="1407218"/>
          </a:xfrm>
        </p:spPr>
        <p:txBody>
          <a:bodyPr anchor="b"/>
          <a:lstStyle>
            <a:lvl1pPr>
              <a:defRPr sz="29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1944" y="2263924"/>
            <a:ext cx="3943350" cy="740023"/>
          </a:xfrm>
        </p:spPr>
        <p:txBody>
          <a:bodyPr/>
          <a:lstStyle>
            <a:lvl1pPr marL="0" indent="0">
              <a:buNone/>
              <a:defRPr sz="1184">
                <a:solidFill>
                  <a:schemeClr val="tx1"/>
                </a:solidFill>
              </a:defRPr>
            </a:lvl1pPr>
            <a:lvl2pPr marL="225537" indent="0">
              <a:buNone/>
              <a:defRPr sz="987">
                <a:solidFill>
                  <a:schemeClr val="tx1">
                    <a:tint val="75000"/>
                  </a:schemeClr>
                </a:solidFill>
              </a:defRPr>
            </a:lvl2pPr>
            <a:lvl3pPr marL="451074" indent="0">
              <a:buNone/>
              <a:defRPr sz="888">
                <a:solidFill>
                  <a:schemeClr val="tx1">
                    <a:tint val="75000"/>
                  </a:schemeClr>
                </a:solidFill>
              </a:defRPr>
            </a:lvl3pPr>
            <a:lvl4pPr marL="676610" indent="0">
              <a:buNone/>
              <a:defRPr sz="789">
                <a:solidFill>
                  <a:schemeClr val="tx1">
                    <a:tint val="75000"/>
                  </a:schemeClr>
                </a:solidFill>
              </a:defRPr>
            </a:lvl4pPr>
            <a:lvl5pPr marL="902147" indent="0">
              <a:buNone/>
              <a:defRPr sz="789">
                <a:solidFill>
                  <a:schemeClr val="tx1">
                    <a:tint val="75000"/>
                  </a:schemeClr>
                </a:solidFill>
              </a:defRPr>
            </a:lvl5pPr>
            <a:lvl6pPr marL="1127684" indent="0">
              <a:buNone/>
              <a:defRPr sz="789">
                <a:solidFill>
                  <a:schemeClr val="tx1">
                    <a:tint val="75000"/>
                  </a:schemeClr>
                </a:solidFill>
              </a:defRPr>
            </a:lvl6pPr>
            <a:lvl7pPr marL="1353221" indent="0">
              <a:buNone/>
              <a:defRPr sz="789">
                <a:solidFill>
                  <a:schemeClr val="tx1">
                    <a:tint val="75000"/>
                  </a:schemeClr>
                </a:solidFill>
              </a:defRPr>
            </a:lvl7pPr>
            <a:lvl8pPr marL="1578757" indent="0">
              <a:buNone/>
              <a:defRPr sz="789">
                <a:solidFill>
                  <a:schemeClr val="tx1">
                    <a:tint val="75000"/>
                  </a:schemeClr>
                </a:solidFill>
              </a:defRPr>
            </a:lvl8pPr>
            <a:lvl9pPr marL="1804294" indent="0">
              <a:buNone/>
              <a:defRPr sz="78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A0D40-68A1-F040-9BD5-36D632BB7D3C}" type="datetimeFigureOut">
              <a:rPr lang="en-US" smtClean="0"/>
              <a:t>9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A6C77-EFDD-C042-999E-4715030A8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61709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14325" y="900557"/>
            <a:ext cx="1943100" cy="214645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314575" y="900557"/>
            <a:ext cx="1943100" cy="214645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A0D40-68A1-F040-9BD5-36D632BB7D3C}" type="datetimeFigureOut">
              <a:rPr lang="en-US" smtClean="0"/>
              <a:t>9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A6C77-EFDD-C042-999E-4715030A8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99741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4921" y="180112"/>
            <a:ext cx="3943350" cy="65388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4921" y="829296"/>
            <a:ext cx="1934170" cy="406425"/>
          </a:xfrm>
        </p:spPr>
        <p:txBody>
          <a:bodyPr anchor="b"/>
          <a:lstStyle>
            <a:lvl1pPr marL="0" indent="0">
              <a:buNone/>
              <a:defRPr sz="1184" b="1"/>
            </a:lvl1pPr>
            <a:lvl2pPr marL="225537" indent="0">
              <a:buNone/>
              <a:defRPr sz="987" b="1"/>
            </a:lvl2pPr>
            <a:lvl3pPr marL="451074" indent="0">
              <a:buNone/>
              <a:defRPr sz="888" b="1"/>
            </a:lvl3pPr>
            <a:lvl4pPr marL="676610" indent="0">
              <a:buNone/>
              <a:defRPr sz="789" b="1"/>
            </a:lvl4pPr>
            <a:lvl5pPr marL="902147" indent="0">
              <a:buNone/>
              <a:defRPr sz="789" b="1"/>
            </a:lvl5pPr>
            <a:lvl6pPr marL="1127684" indent="0">
              <a:buNone/>
              <a:defRPr sz="789" b="1"/>
            </a:lvl6pPr>
            <a:lvl7pPr marL="1353221" indent="0">
              <a:buNone/>
              <a:defRPr sz="789" b="1"/>
            </a:lvl7pPr>
            <a:lvl8pPr marL="1578757" indent="0">
              <a:buNone/>
              <a:defRPr sz="789" b="1"/>
            </a:lvl8pPr>
            <a:lvl9pPr marL="1804294" indent="0">
              <a:buNone/>
              <a:defRPr sz="789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4921" y="1235721"/>
            <a:ext cx="1934170" cy="181756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314575" y="829296"/>
            <a:ext cx="1943696" cy="406425"/>
          </a:xfrm>
        </p:spPr>
        <p:txBody>
          <a:bodyPr anchor="b"/>
          <a:lstStyle>
            <a:lvl1pPr marL="0" indent="0">
              <a:buNone/>
              <a:defRPr sz="1184" b="1"/>
            </a:lvl1pPr>
            <a:lvl2pPr marL="225537" indent="0">
              <a:buNone/>
              <a:defRPr sz="987" b="1"/>
            </a:lvl2pPr>
            <a:lvl3pPr marL="451074" indent="0">
              <a:buNone/>
              <a:defRPr sz="888" b="1"/>
            </a:lvl3pPr>
            <a:lvl4pPr marL="676610" indent="0">
              <a:buNone/>
              <a:defRPr sz="789" b="1"/>
            </a:lvl4pPr>
            <a:lvl5pPr marL="902147" indent="0">
              <a:buNone/>
              <a:defRPr sz="789" b="1"/>
            </a:lvl5pPr>
            <a:lvl6pPr marL="1127684" indent="0">
              <a:buNone/>
              <a:defRPr sz="789" b="1"/>
            </a:lvl6pPr>
            <a:lvl7pPr marL="1353221" indent="0">
              <a:buNone/>
              <a:defRPr sz="789" b="1"/>
            </a:lvl7pPr>
            <a:lvl8pPr marL="1578757" indent="0">
              <a:buNone/>
              <a:defRPr sz="789" b="1"/>
            </a:lvl8pPr>
            <a:lvl9pPr marL="1804294" indent="0">
              <a:buNone/>
              <a:defRPr sz="789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314575" y="1235721"/>
            <a:ext cx="1943696" cy="181756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A0D40-68A1-F040-9BD5-36D632BB7D3C}" type="datetimeFigureOut">
              <a:rPr lang="en-US" smtClean="0"/>
              <a:t>9/1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A6C77-EFDD-C042-999E-4715030A8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73262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A0D40-68A1-F040-9BD5-36D632BB7D3C}" type="datetimeFigureOut">
              <a:rPr lang="en-US" smtClean="0"/>
              <a:t>9/1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A6C77-EFDD-C042-999E-4715030A8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87525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A0D40-68A1-F040-9BD5-36D632BB7D3C}" type="datetimeFigureOut">
              <a:rPr lang="en-US" smtClean="0"/>
              <a:t>9/1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A6C77-EFDD-C042-999E-4715030A8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71815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4921" y="225531"/>
            <a:ext cx="1474589" cy="789358"/>
          </a:xfrm>
        </p:spPr>
        <p:txBody>
          <a:bodyPr anchor="b"/>
          <a:lstStyle>
            <a:lvl1pPr>
              <a:defRPr sz="157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943695" y="487085"/>
            <a:ext cx="2314575" cy="2404096"/>
          </a:xfrm>
        </p:spPr>
        <p:txBody>
          <a:bodyPr/>
          <a:lstStyle>
            <a:lvl1pPr>
              <a:defRPr sz="1579"/>
            </a:lvl1pPr>
            <a:lvl2pPr>
              <a:defRPr sz="1381"/>
            </a:lvl2pPr>
            <a:lvl3pPr>
              <a:defRPr sz="1184"/>
            </a:lvl3pPr>
            <a:lvl4pPr>
              <a:defRPr sz="987"/>
            </a:lvl4pPr>
            <a:lvl5pPr>
              <a:defRPr sz="987"/>
            </a:lvl5pPr>
            <a:lvl6pPr>
              <a:defRPr sz="987"/>
            </a:lvl6pPr>
            <a:lvl7pPr>
              <a:defRPr sz="987"/>
            </a:lvl7pPr>
            <a:lvl8pPr>
              <a:defRPr sz="987"/>
            </a:lvl8pPr>
            <a:lvl9pPr>
              <a:defRPr sz="987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14921" y="1014889"/>
            <a:ext cx="1474589" cy="1880207"/>
          </a:xfrm>
        </p:spPr>
        <p:txBody>
          <a:bodyPr/>
          <a:lstStyle>
            <a:lvl1pPr marL="0" indent="0">
              <a:buNone/>
              <a:defRPr sz="789"/>
            </a:lvl1pPr>
            <a:lvl2pPr marL="225537" indent="0">
              <a:buNone/>
              <a:defRPr sz="691"/>
            </a:lvl2pPr>
            <a:lvl3pPr marL="451074" indent="0">
              <a:buNone/>
              <a:defRPr sz="592"/>
            </a:lvl3pPr>
            <a:lvl4pPr marL="676610" indent="0">
              <a:buNone/>
              <a:defRPr sz="493"/>
            </a:lvl4pPr>
            <a:lvl5pPr marL="902147" indent="0">
              <a:buNone/>
              <a:defRPr sz="493"/>
            </a:lvl5pPr>
            <a:lvl6pPr marL="1127684" indent="0">
              <a:buNone/>
              <a:defRPr sz="493"/>
            </a:lvl6pPr>
            <a:lvl7pPr marL="1353221" indent="0">
              <a:buNone/>
              <a:defRPr sz="493"/>
            </a:lvl7pPr>
            <a:lvl8pPr marL="1578757" indent="0">
              <a:buNone/>
              <a:defRPr sz="493"/>
            </a:lvl8pPr>
            <a:lvl9pPr marL="1804294" indent="0">
              <a:buNone/>
              <a:defRPr sz="49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A0D40-68A1-F040-9BD5-36D632BB7D3C}" type="datetimeFigureOut">
              <a:rPr lang="en-US" smtClean="0"/>
              <a:t>9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A6C77-EFDD-C042-999E-4715030A8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65465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4921" y="225531"/>
            <a:ext cx="1474589" cy="789358"/>
          </a:xfrm>
        </p:spPr>
        <p:txBody>
          <a:bodyPr anchor="b"/>
          <a:lstStyle>
            <a:lvl1pPr>
              <a:defRPr sz="157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943695" y="487085"/>
            <a:ext cx="2314575" cy="2404096"/>
          </a:xfrm>
        </p:spPr>
        <p:txBody>
          <a:bodyPr anchor="t"/>
          <a:lstStyle>
            <a:lvl1pPr marL="0" indent="0">
              <a:buNone/>
              <a:defRPr sz="1579"/>
            </a:lvl1pPr>
            <a:lvl2pPr marL="225537" indent="0">
              <a:buNone/>
              <a:defRPr sz="1381"/>
            </a:lvl2pPr>
            <a:lvl3pPr marL="451074" indent="0">
              <a:buNone/>
              <a:defRPr sz="1184"/>
            </a:lvl3pPr>
            <a:lvl4pPr marL="676610" indent="0">
              <a:buNone/>
              <a:defRPr sz="987"/>
            </a:lvl4pPr>
            <a:lvl5pPr marL="902147" indent="0">
              <a:buNone/>
              <a:defRPr sz="987"/>
            </a:lvl5pPr>
            <a:lvl6pPr marL="1127684" indent="0">
              <a:buNone/>
              <a:defRPr sz="987"/>
            </a:lvl6pPr>
            <a:lvl7pPr marL="1353221" indent="0">
              <a:buNone/>
              <a:defRPr sz="987"/>
            </a:lvl7pPr>
            <a:lvl8pPr marL="1578757" indent="0">
              <a:buNone/>
              <a:defRPr sz="987"/>
            </a:lvl8pPr>
            <a:lvl9pPr marL="1804294" indent="0">
              <a:buNone/>
              <a:defRPr sz="98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14921" y="1014889"/>
            <a:ext cx="1474589" cy="1880207"/>
          </a:xfrm>
        </p:spPr>
        <p:txBody>
          <a:bodyPr/>
          <a:lstStyle>
            <a:lvl1pPr marL="0" indent="0">
              <a:buNone/>
              <a:defRPr sz="789"/>
            </a:lvl1pPr>
            <a:lvl2pPr marL="225537" indent="0">
              <a:buNone/>
              <a:defRPr sz="691"/>
            </a:lvl2pPr>
            <a:lvl3pPr marL="451074" indent="0">
              <a:buNone/>
              <a:defRPr sz="592"/>
            </a:lvl3pPr>
            <a:lvl4pPr marL="676610" indent="0">
              <a:buNone/>
              <a:defRPr sz="493"/>
            </a:lvl4pPr>
            <a:lvl5pPr marL="902147" indent="0">
              <a:buNone/>
              <a:defRPr sz="493"/>
            </a:lvl5pPr>
            <a:lvl6pPr marL="1127684" indent="0">
              <a:buNone/>
              <a:defRPr sz="493"/>
            </a:lvl6pPr>
            <a:lvl7pPr marL="1353221" indent="0">
              <a:buNone/>
              <a:defRPr sz="493"/>
            </a:lvl7pPr>
            <a:lvl8pPr marL="1578757" indent="0">
              <a:buNone/>
              <a:defRPr sz="493"/>
            </a:lvl8pPr>
            <a:lvl9pPr marL="1804294" indent="0">
              <a:buNone/>
              <a:defRPr sz="49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5A0D40-68A1-F040-9BD5-36D632BB7D3C}" type="datetimeFigureOut">
              <a:rPr lang="en-US" smtClean="0"/>
              <a:t>9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A6C77-EFDD-C042-999E-4715030A8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32008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14325" y="180112"/>
            <a:ext cx="3943350" cy="65388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4325" y="900557"/>
            <a:ext cx="3943350" cy="214645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14325" y="3135506"/>
            <a:ext cx="1028700" cy="180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5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5A0D40-68A1-F040-9BD5-36D632BB7D3C}" type="datetimeFigureOut">
              <a:rPr lang="en-US" smtClean="0"/>
              <a:t>9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514475" y="3135506"/>
            <a:ext cx="1543050" cy="180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5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228975" y="3135506"/>
            <a:ext cx="1028700" cy="180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5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2A6C77-EFDD-C042-999E-4715030A86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34729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451074" rtl="0" eaLnBrk="1" latinLnBrk="0" hangingPunct="1">
        <a:lnSpc>
          <a:spcPct val="90000"/>
        </a:lnSpc>
        <a:spcBef>
          <a:spcPct val="0"/>
        </a:spcBef>
        <a:buNone/>
        <a:defRPr sz="217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12768" indent="-112768" algn="l" defTabSz="451074" rtl="0" eaLnBrk="1" latinLnBrk="0" hangingPunct="1">
        <a:lnSpc>
          <a:spcPct val="90000"/>
        </a:lnSpc>
        <a:spcBef>
          <a:spcPts val="493"/>
        </a:spcBef>
        <a:buFont typeface="Arial" panose="020B0604020202020204" pitchFamily="34" charset="0"/>
        <a:buChar char="•"/>
        <a:defRPr sz="1381" kern="1200">
          <a:solidFill>
            <a:schemeClr val="tx1"/>
          </a:solidFill>
          <a:latin typeface="+mn-lt"/>
          <a:ea typeface="+mn-ea"/>
          <a:cs typeface="+mn-cs"/>
        </a:defRPr>
      </a:lvl1pPr>
      <a:lvl2pPr marL="338305" indent="-112768" algn="l" defTabSz="451074" rtl="0" eaLnBrk="1" latinLnBrk="0" hangingPunct="1">
        <a:lnSpc>
          <a:spcPct val="90000"/>
        </a:lnSpc>
        <a:spcBef>
          <a:spcPts val="247"/>
        </a:spcBef>
        <a:buFont typeface="Arial" panose="020B0604020202020204" pitchFamily="34" charset="0"/>
        <a:buChar char="•"/>
        <a:defRPr sz="1184" kern="1200">
          <a:solidFill>
            <a:schemeClr val="tx1"/>
          </a:solidFill>
          <a:latin typeface="+mn-lt"/>
          <a:ea typeface="+mn-ea"/>
          <a:cs typeface="+mn-cs"/>
        </a:defRPr>
      </a:lvl2pPr>
      <a:lvl3pPr marL="563842" indent="-112768" algn="l" defTabSz="451074" rtl="0" eaLnBrk="1" latinLnBrk="0" hangingPunct="1">
        <a:lnSpc>
          <a:spcPct val="90000"/>
        </a:lnSpc>
        <a:spcBef>
          <a:spcPts val="247"/>
        </a:spcBef>
        <a:buFont typeface="Arial" panose="020B0604020202020204" pitchFamily="34" charset="0"/>
        <a:buChar char="•"/>
        <a:defRPr sz="987" kern="1200">
          <a:solidFill>
            <a:schemeClr val="tx1"/>
          </a:solidFill>
          <a:latin typeface="+mn-lt"/>
          <a:ea typeface="+mn-ea"/>
          <a:cs typeface="+mn-cs"/>
        </a:defRPr>
      </a:lvl3pPr>
      <a:lvl4pPr marL="789379" indent="-112768" algn="l" defTabSz="451074" rtl="0" eaLnBrk="1" latinLnBrk="0" hangingPunct="1">
        <a:lnSpc>
          <a:spcPct val="90000"/>
        </a:lnSpc>
        <a:spcBef>
          <a:spcPts val="247"/>
        </a:spcBef>
        <a:buFont typeface="Arial" panose="020B0604020202020204" pitchFamily="34" charset="0"/>
        <a:buChar char="•"/>
        <a:defRPr sz="888" kern="1200">
          <a:solidFill>
            <a:schemeClr val="tx1"/>
          </a:solidFill>
          <a:latin typeface="+mn-lt"/>
          <a:ea typeface="+mn-ea"/>
          <a:cs typeface="+mn-cs"/>
        </a:defRPr>
      </a:lvl4pPr>
      <a:lvl5pPr marL="1014915" indent="-112768" algn="l" defTabSz="451074" rtl="0" eaLnBrk="1" latinLnBrk="0" hangingPunct="1">
        <a:lnSpc>
          <a:spcPct val="90000"/>
        </a:lnSpc>
        <a:spcBef>
          <a:spcPts val="247"/>
        </a:spcBef>
        <a:buFont typeface="Arial" panose="020B0604020202020204" pitchFamily="34" charset="0"/>
        <a:buChar char="•"/>
        <a:defRPr sz="888" kern="1200">
          <a:solidFill>
            <a:schemeClr val="tx1"/>
          </a:solidFill>
          <a:latin typeface="+mn-lt"/>
          <a:ea typeface="+mn-ea"/>
          <a:cs typeface="+mn-cs"/>
        </a:defRPr>
      </a:lvl5pPr>
      <a:lvl6pPr marL="1240452" indent="-112768" algn="l" defTabSz="451074" rtl="0" eaLnBrk="1" latinLnBrk="0" hangingPunct="1">
        <a:lnSpc>
          <a:spcPct val="90000"/>
        </a:lnSpc>
        <a:spcBef>
          <a:spcPts val="247"/>
        </a:spcBef>
        <a:buFont typeface="Arial" panose="020B0604020202020204" pitchFamily="34" charset="0"/>
        <a:buChar char="•"/>
        <a:defRPr sz="888" kern="1200">
          <a:solidFill>
            <a:schemeClr val="tx1"/>
          </a:solidFill>
          <a:latin typeface="+mn-lt"/>
          <a:ea typeface="+mn-ea"/>
          <a:cs typeface="+mn-cs"/>
        </a:defRPr>
      </a:lvl6pPr>
      <a:lvl7pPr marL="1465989" indent="-112768" algn="l" defTabSz="451074" rtl="0" eaLnBrk="1" latinLnBrk="0" hangingPunct="1">
        <a:lnSpc>
          <a:spcPct val="90000"/>
        </a:lnSpc>
        <a:spcBef>
          <a:spcPts val="247"/>
        </a:spcBef>
        <a:buFont typeface="Arial" panose="020B0604020202020204" pitchFamily="34" charset="0"/>
        <a:buChar char="•"/>
        <a:defRPr sz="888" kern="1200">
          <a:solidFill>
            <a:schemeClr val="tx1"/>
          </a:solidFill>
          <a:latin typeface="+mn-lt"/>
          <a:ea typeface="+mn-ea"/>
          <a:cs typeface="+mn-cs"/>
        </a:defRPr>
      </a:lvl7pPr>
      <a:lvl8pPr marL="1691526" indent="-112768" algn="l" defTabSz="451074" rtl="0" eaLnBrk="1" latinLnBrk="0" hangingPunct="1">
        <a:lnSpc>
          <a:spcPct val="90000"/>
        </a:lnSpc>
        <a:spcBef>
          <a:spcPts val="247"/>
        </a:spcBef>
        <a:buFont typeface="Arial" panose="020B0604020202020204" pitchFamily="34" charset="0"/>
        <a:buChar char="•"/>
        <a:defRPr sz="888" kern="1200">
          <a:solidFill>
            <a:schemeClr val="tx1"/>
          </a:solidFill>
          <a:latin typeface="+mn-lt"/>
          <a:ea typeface="+mn-ea"/>
          <a:cs typeface="+mn-cs"/>
        </a:defRPr>
      </a:lvl8pPr>
      <a:lvl9pPr marL="1917062" indent="-112768" algn="l" defTabSz="451074" rtl="0" eaLnBrk="1" latinLnBrk="0" hangingPunct="1">
        <a:lnSpc>
          <a:spcPct val="90000"/>
        </a:lnSpc>
        <a:spcBef>
          <a:spcPts val="247"/>
        </a:spcBef>
        <a:buFont typeface="Arial" panose="020B0604020202020204" pitchFamily="34" charset="0"/>
        <a:buChar char="•"/>
        <a:defRPr sz="8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1074" rtl="0" eaLnBrk="1" latinLnBrk="0" hangingPunct="1">
        <a:defRPr sz="888" kern="1200">
          <a:solidFill>
            <a:schemeClr val="tx1"/>
          </a:solidFill>
          <a:latin typeface="+mn-lt"/>
          <a:ea typeface="+mn-ea"/>
          <a:cs typeface="+mn-cs"/>
        </a:defRPr>
      </a:lvl1pPr>
      <a:lvl2pPr marL="225537" algn="l" defTabSz="451074" rtl="0" eaLnBrk="1" latinLnBrk="0" hangingPunct="1">
        <a:defRPr sz="888" kern="1200">
          <a:solidFill>
            <a:schemeClr val="tx1"/>
          </a:solidFill>
          <a:latin typeface="+mn-lt"/>
          <a:ea typeface="+mn-ea"/>
          <a:cs typeface="+mn-cs"/>
        </a:defRPr>
      </a:lvl2pPr>
      <a:lvl3pPr marL="451074" algn="l" defTabSz="451074" rtl="0" eaLnBrk="1" latinLnBrk="0" hangingPunct="1">
        <a:defRPr sz="888" kern="1200">
          <a:solidFill>
            <a:schemeClr val="tx1"/>
          </a:solidFill>
          <a:latin typeface="+mn-lt"/>
          <a:ea typeface="+mn-ea"/>
          <a:cs typeface="+mn-cs"/>
        </a:defRPr>
      </a:lvl3pPr>
      <a:lvl4pPr marL="676610" algn="l" defTabSz="451074" rtl="0" eaLnBrk="1" latinLnBrk="0" hangingPunct="1">
        <a:defRPr sz="888" kern="1200">
          <a:solidFill>
            <a:schemeClr val="tx1"/>
          </a:solidFill>
          <a:latin typeface="+mn-lt"/>
          <a:ea typeface="+mn-ea"/>
          <a:cs typeface="+mn-cs"/>
        </a:defRPr>
      </a:lvl4pPr>
      <a:lvl5pPr marL="902147" algn="l" defTabSz="451074" rtl="0" eaLnBrk="1" latinLnBrk="0" hangingPunct="1">
        <a:defRPr sz="888" kern="1200">
          <a:solidFill>
            <a:schemeClr val="tx1"/>
          </a:solidFill>
          <a:latin typeface="+mn-lt"/>
          <a:ea typeface="+mn-ea"/>
          <a:cs typeface="+mn-cs"/>
        </a:defRPr>
      </a:lvl5pPr>
      <a:lvl6pPr marL="1127684" algn="l" defTabSz="451074" rtl="0" eaLnBrk="1" latinLnBrk="0" hangingPunct="1">
        <a:defRPr sz="888" kern="1200">
          <a:solidFill>
            <a:schemeClr val="tx1"/>
          </a:solidFill>
          <a:latin typeface="+mn-lt"/>
          <a:ea typeface="+mn-ea"/>
          <a:cs typeface="+mn-cs"/>
        </a:defRPr>
      </a:lvl6pPr>
      <a:lvl7pPr marL="1353221" algn="l" defTabSz="451074" rtl="0" eaLnBrk="1" latinLnBrk="0" hangingPunct="1">
        <a:defRPr sz="888" kern="1200">
          <a:solidFill>
            <a:schemeClr val="tx1"/>
          </a:solidFill>
          <a:latin typeface="+mn-lt"/>
          <a:ea typeface="+mn-ea"/>
          <a:cs typeface="+mn-cs"/>
        </a:defRPr>
      </a:lvl7pPr>
      <a:lvl8pPr marL="1578757" algn="l" defTabSz="451074" rtl="0" eaLnBrk="1" latinLnBrk="0" hangingPunct="1">
        <a:defRPr sz="888" kern="1200">
          <a:solidFill>
            <a:schemeClr val="tx1"/>
          </a:solidFill>
          <a:latin typeface="+mn-lt"/>
          <a:ea typeface="+mn-ea"/>
          <a:cs typeface="+mn-cs"/>
        </a:defRPr>
      </a:lvl8pPr>
      <a:lvl9pPr marL="1804294" algn="l" defTabSz="451074" rtl="0" eaLnBrk="1" latinLnBrk="0" hangingPunct="1">
        <a:defRPr sz="8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47">
            <a:extLst>
              <a:ext uri="{FF2B5EF4-FFF2-40B4-BE49-F238E27FC236}">
                <a16:creationId xmlns:a16="http://schemas.microsoft.com/office/drawing/2014/main" id="{E432F60B-F05A-42E0-9C0C-BF0E6C3AB015}"/>
              </a:ext>
            </a:extLst>
          </p:cNvPr>
          <p:cNvSpPr txBox="1"/>
          <p:nvPr/>
        </p:nvSpPr>
        <p:spPr>
          <a:xfrm>
            <a:off x="363773" y="208282"/>
            <a:ext cx="37987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mmunoblotting of</a:t>
            </a:r>
            <a:r>
              <a:rPr lang="en-US" sz="1400" b="1" dirty="0">
                <a:latin typeface="Arial" panose="020B0604020202020204" pitchFamily="34" charset="0"/>
                <a:ea typeface="PMingLiU" panose="02020500000000000000" pitchFamily="18" charset="-120"/>
                <a:cs typeface="Arial" panose="020B0604020202020204" pitchFamily="34" charset="0"/>
              </a:rPr>
              <a:t> colon tissues in the rat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2A5B7F2E-9B4A-4A33-9E3F-B3AD0C04B75C}"/>
              </a:ext>
            </a:extLst>
          </p:cNvPr>
          <p:cNvSpPr txBox="1"/>
          <p:nvPr/>
        </p:nvSpPr>
        <p:spPr>
          <a:xfrm>
            <a:off x="310402" y="2633027"/>
            <a:ext cx="39996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, tumor; N, matched normal-looking colonic </a:t>
            </a:r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mucosa; WT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, wild type. Loading control, </a:t>
            </a:r>
            <a:r>
              <a:rPr lang="en-US" sz="14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actin.</a:t>
            </a:r>
          </a:p>
        </p:txBody>
      </p:sp>
      <p:pic>
        <p:nvPicPr>
          <p:cNvPr id="47" name="Picture 46">
            <a:extLst>
              <a:ext uri="{FF2B5EF4-FFF2-40B4-BE49-F238E27FC236}">
                <a16:creationId xmlns:a16="http://schemas.microsoft.com/office/drawing/2014/main" id="{A1A19922-F355-4AC3-BFD3-8F666B7661D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025" t="18234" r="23412"/>
          <a:stretch/>
        </p:blipFill>
        <p:spPr>
          <a:xfrm>
            <a:off x="1208487" y="984121"/>
            <a:ext cx="1818861" cy="152665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C30C425C-1E82-4CFB-ACCD-F169A582C0A9}"/>
              </a:ext>
            </a:extLst>
          </p:cNvPr>
          <p:cNvSpPr txBox="1"/>
          <p:nvPr/>
        </p:nvSpPr>
        <p:spPr>
          <a:xfrm>
            <a:off x="1336702" y="736664"/>
            <a:ext cx="376694" cy="261610"/>
          </a:xfrm>
          <a:prstGeom prst="rect">
            <a:avLst/>
          </a:prstGeom>
          <a:noFill/>
        </p:spPr>
        <p:txBody>
          <a:bodyPr wrap="square" lIns="0" tIns="0" rIns="0" bIns="91440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9CD7AEF-CE2C-4DB6-8567-E2C6ABF4F130}"/>
              </a:ext>
            </a:extLst>
          </p:cNvPr>
          <p:cNvSpPr txBox="1"/>
          <p:nvPr/>
        </p:nvSpPr>
        <p:spPr>
          <a:xfrm>
            <a:off x="2209044" y="642182"/>
            <a:ext cx="376694" cy="261610"/>
          </a:xfrm>
          <a:prstGeom prst="rect">
            <a:avLst/>
          </a:prstGeom>
          <a:noFill/>
        </p:spPr>
        <p:txBody>
          <a:bodyPr wrap="square" lIns="0" tIns="0" rIns="0" bIns="91440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ir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259F1B0-3124-4A64-B5B3-3452C4D20B08}"/>
              </a:ext>
            </a:extLst>
          </p:cNvPr>
          <p:cNvSpPr txBox="1"/>
          <p:nvPr/>
        </p:nvSpPr>
        <p:spPr>
          <a:xfrm>
            <a:off x="1833660" y="853316"/>
            <a:ext cx="167309" cy="261610"/>
          </a:xfrm>
          <a:prstGeom prst="rect">
            <a:avLst/>
          </a:prstGeom>
          <a:noFill/>
        </p:spPr>
        <p:txBody>
          <a:bodyPr wrap="square" lIns="0" tIns="0" rIns="0" bIns="91440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DFB7BB4-4308-4848-B5C3-9C62B3C4CC7F}"/>
              </a:ext>
            </a:extLst>
          </p:cNvPr>
          <p:cNvSpPr txBox="1"/>
          <p:nvPr/>
        </p:nvSpPr>
        <p:spPr>
          <a:xfrm>
            <a:off x="2226586" y="853316"/>
            <a:ext cx="167309" cy="261610"/>
          </a:xfrm>
          <a:prstGeom prst="rect">
            <a:avLst/>
          </a:prstGeom>
          <a:noFill/>
        </p:spPr>
        <p:txBody>
          <a:bodyPr wrap="square" lIns="0" tIns="0" rIns="0" bIns="91440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34678F6-7859-4937-97C8-A40CD1CC0A8C}"/>
              </a:ext>
            </a:extLst>
          </p:cNvPr>
          <p:cNvSpPr txBox="1"/>
          <p:nvPr/>
        </p:nvSpPr>
        <p:spPr>
          <a:xfrm>
            <a:off x="2634349" y="853316"/>
            <a:ext cx="167309" cy="261610"/>
          </a:xfrm>
          <a:prstGeom prst="rect">
            <a:avLst/>
          </a:prstGeom>
          <a:noFill/>
        </p:spPr>
        <p:txBody>
          <a:bodyPr wrap="square" lIns="0" tIns="0" rIns="0" bIns="91440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4E984DC-8D6A-41B3-B7E5-663E68154FD2}"/>
              </a:ext>
            </a:extLst>
          </p:cNvPr>
          <p:cNvSpPr txBox="1"/>
          <p:nvPr/>
        </p:nvSpPr>
        <p:spPr>
          <a:xfrm>
            <a:off x="2035222" y="854876"/>
            <a:ext cx="167309" cy="261610"/>
          </a:xfrm>
          <a:prstGeom prst="rect">
            <a:avLst/>
          </a:prstGeom>
          <a:noFill/>
        </p:spPr>
        <p:txBody>
          <a:bodyPr wrap="square" lIns="0" tIns="0" rIns="0" bIns="91440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271E03E-9C70-4164-90F4-0834A62CB0A5}"/>
              </a:ext>
            </a:extLst>
          </p:cNvPr>
          <p:cNvSpPr txBox="1"/>
          <p:nvPr/>
        </p:nvSpPr>
        <p:spPr>
          <a:xfrm>
            <a:off x="2433413" y="854876"/>
            <a:ext cx="167309" cy="261610"/>
          </a:xfrm>
          <a:prstGeom prst="rect">
            <a:avLst/>
          </a:prstGeom>
          <a:noFill/>
        </p:spPr>
        <p:txBody>
          <a:bodyPr wrap="square" lIns="0" tIns="0" rIns="0" bIns="91440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93A8B1D-759F-48DE-8D4C-116B183F742F}"/>
              </a:ext>
            </a:extLst>
          </p:cNvPr>
          <p:cNvSpPr txBox="1"/>
          <p:nvPr/>
        </p:nvSpPr>
        <p:spPr>
          <a:xfrm>
            <a:off x="2832377" y="853316"/>
            <a:ext cx="167309" cy="261610"/>
          </a:xfrm>
          <a:prstGeom prst="rect">
            <a:avLst/>
          </a:prstGeom>
          <a:noFill/>
        </p:spPr>
        <p:txBody>
          <a:bodyPr wrap="square" lIns="0" tIns="0" rIns="0" bIns="91440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759B750C-B7C9-4AEC-8166-31DE34B18FF7}"/>
              </a:ext>
            </a:extLst>
          </p:cNvPr>
          <p:cNvSpPr/>
          <p:nvPr/>
        </p:nvSpPr>
        <p:spPr>
          <a:xfrm>
            <a:off x="1207991" y="946153"/>
            <a:ext cx="593762" cy="9144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4A0838CA-A56F-46EE-B587-024D992770E4}"/>
              </a:ext>
            </a:extLst>
          </p:cNvPr>
          <p:cNvSpPr/>
          <p:nvPr/>
        </p:nvSpPr>
        <p:spPr>
          <a:xfrm>
            <a:off x="1856538" y="836588"/>
            <a:ext cx="1097280" cy="9144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10EE209-F252-492A-90B4-C2862E8DBD05}"/>
              </a:ext>
            </a:extLst>
          </p:cNvPr>
          <p:cNvSpPr txBox="1"/>
          <p:nvPr/>
        </p:nvSpPr>
        <p:spPr>
          <a:xfrm>
            <a:off x="3057296" y="1087442"/>
            <a:ext cx="426593" cy="159868"/>
          </a:xfrm>
          <a:prstGeom prst="rect">
            <a:avLst/>
          </a:prstGeom>
          <a:noFill/>
        </p:spPr>
        <p:txBody>
          <a:bodyPr wrap="square" lIns="0" tIns="0" rIns="0" bIns="91440" rtlCol="0">
            <a:no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ARP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DDE816A-B4A6-47BF-8C94-D4555C759A94}"/>
              </a:ext>
            </a:extLst>
          </p:cNvPr>
          <p:cNvSpPr txBox="1"/>
          <p:nvPr/>
        </p:nvSpPr>
        <p:spPr>
          <a:xfrm>
            <a:off x="3057296" y="1422721"/>
            <a:ext cx="644975" cy="159868"/>
          </a:xfrm>
          <a:prstGeom prst="rect">
            <a:avLst/>
          </a:prstGeom>
          <a:noFill/>
        </p:spPr>
        <p:txBody>
          <a:bodyPr wrap="square" lIns="0" tIns="0" rIns="0" bIns="91440" rtlCol="0">
            <a:noAutofit/>
          </a:bodyPr>
          <a:lstStyle/>
          <a:p>
            <a:r>
              <a:rPr lang="en-US" sz="11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catenin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D33245C-F8BF-4DE6-B437-C1A87C317C3E}"/>
              </a:ext>
            </a:extLst>
          </p:cNvPr>
          <p:cNvSpPr txBox="1"/>
          <p:nvPr/>
        </p:nvSpPr>
        <p:spPr>
          <a:xfrm>
            <a:off x="3057296" y="1732648"/>
            <a:ext cx="426593" cy="159868"/>
          </a:xfrm>
          <a:prstGeom prst="rect">
            <a:avLst/>
          </a:prstGeom>
          <a:noFill/>
        </p:spPr>
        <p:txBody>
          <a:bodyPr wrap="square" lIns="0" tIns="0" rIns="0" bIns="91440" rtlCol="0">
            <a:no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D12D0C3-9170-4CBD-97E6-E1A131CBC981}"/>
              </a:ext>
            </a:extLst>
          </p:cNvPr>
          <p:cNvSpPr txBox="1"/>
          <p:nvPr/>
        </p:nvSpPr>
        <p:spPr>
          <a:xfrm>
            <a:off x="3057296" y="1987993"/>
            <a:ext cx="607094" cy="159868"/>
          </a:xfrm>
          <a:prstGeom prst="rect">
            <a:avLst/>
          </a:prstGeom>
          <a:noFill/>
        </p:spPr>
        <p:txBody>
          <a:bodyPr wrap="square" lIns="0" tIns="0" rIns="0" bIns="91440" rtlCol="0">
            <a:no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yclin D1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7183891-6533-4E08-98D0-FD6BF796E5A1}"/>
              </a:ext>
            </a:extLst>
          </p:cNvPr>
          <p:cNvSpPr txBox="1"/>
          <p:nvPr/>
        </p:nvSpPr>
        <p:spPr>
          <a:xfrm>
            <a:off x="3057296" y="2274283"/>
            <a:ext cx="644975" cy="159868"/>
          </a:xfrm>
          <a:prstGeom prst="rect">
            <a:avLst/>
          </a:prstGeom>
          <a:noFill/>
        </p:spPr>
        <p:txBody>
          <a:bodyPr wrap="square" lIns="0" tIns="0" rIns="0" bIns="91440" rtlCol="0">
            <a:noAutofit/>
          </a:bodyPr>
          <a:lstStyle/>
          <a:p>
            <a:r>
              <a:rPr lang="en-US" sz="11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5E473E30-C724-475E-8DB3-408E44D68171}"/>
              </a:ext>
            </a:extLst>
          </p:cNvPr>
          <p:cNvSpPr/>
          <p:nvPr/>
        </p:nvSpPr>
        <p:spPr>
          <a:xfrm>
            <a:off x="1208984" y="2502222"/>
            <a:ext cx="1828800" cy="9144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37020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422</TotalTime>
  <Words>42</Words>
  <Application>Microsoft Office PowerPoint</Application>
  <PresentationFormat>Custom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PMingLiU</vt:lpstr>
      <vt:lpstr>Arial</vt:lpstr>
      <vt:lpstr>Calibri</vt:lpstr>
      <vt:lpstr>Calibri Light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ing-Shiuan Chen</dc:creator>
  <cp:lastModifiedBy>Dashwood, Roderick H.</cp:lastModifiedBy>
  <cp:revision>467</cp:revision>
  <cp:lastPrinted>2020-01-07T17:16:05Z</cp:lastPrinted>
  <dcterms:created xsi:type="dcterms:W3CDTF">2018-06-27T19:28:06Z</dcterms:created>
  <dcterms:modified xsi:type="dcterms:W3CDTF">2020-09-10T16:06:57Z</dcterms:modified>
</cp:coreProperties>
</file>